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3047" autoAdjust="0"/>
  </p:normalViewPr>
  <p:slideViewPr>
    <p:cSldViewPr snapToGrid="0">
      <p:cViewPr varScale="1">
        <p:scale>
          <a:sx n="74" d="100"/>
          <a:sy n="74" d="100"/>
        </p:scale>
        <p:origin x="36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F96209-19D0-4006-B30E-D4CCD893F23F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648205-00DE-4C84-ADAA-90DB6DD2AD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1248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2648205-00DE-4C84-ADAA-90DB6DD2ADE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085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82CC0A-B48A-44CF-D400-8F2B351F6CB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861856C-F8DC-8453-E8E1-DE5B480F0A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250A46-E98D-FDBB-D174-49B22F4C25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AD585-02C3-4E60-B62E-96C39366E3A9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1FEC8C-FFBD-045A-4463-9EE3142C1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754878-BE48-AE9E-0072-31A8BE6BB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EE7C-DA2A-4B38-8566-444DA9AAC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282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E593C6-E7B8-6212-7D78-B17B6D6274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D606C8-2E5C-6F8F-3C9B-E9366BD94F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A50C5D-653C-7D1E-2EF6-2313EF924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AD585-02C3-4E60-B62E-96C39366E3A9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EAA5CB-B53D-5AF2-7761-A44339A03F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7E37BF-3ADD-49AC-D66A-DDE564138C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EE7C-DA2A-4B38-8566-444DA9AAC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306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085E056-7BF3-3DD9-2E21-801EE8329B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D3D70D-91CE-A8AF-0D48-BEABE10C4C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F458C8-1FE3-C336-3C06-60BF6AEA55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AD585-02C3-4E60-B62E-96C39366E3A9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915C9-6793-5BB8-1790-077E87DE2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2B7D9B-D40E-0347-39A8-EAF9B46C7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EE7C-DA2A-4B38-8566-444DA9AAC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26303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915461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D6A285-1868-9AAF-73FF-9059171FD4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2AB8F5-850E-5E5A-2F45-0DDE3C6220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5D994F-7E14-E098-EDAF-7388A582B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AD585-02C3-4E60-B62E-96C39366E3A9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1032DB-BEF5-8589-B581-DA32E1F80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15A3E6-9FCD-A46D-9253-64F4D4D04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EE7C-DA2A-4B38-8566-444DA9AAC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833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5C7F65-C6C2-7617-06EA-00482B8BE7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73ABC0-0CCA-6A71-7880-8FD17E9737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52DC49-7147-B80C-FA90-9C16A6C46E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AD585-02C3-4E60-B62E-96C39366E3A9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D76D4B-CD08-AC09-44A0-DE02256A6B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79AF51-1C40-1F59-0720-80FBE5F38F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EE7C-DA2A-4B38-8566-444DA9AAC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2398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A6087E-F51A-1BF2-29A4-2271B47197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609EFE-8FFE-E3BC-587A-901A69C3E1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B251BA-8FBE-83DD-DA37-875266B3AA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E75969-3DF9-3F29-9080-648D6D4A3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AD585-02C3-4E60-B62E-96C39366E3A9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B813FA-DB8A-19D1-10E0-FBDBED8516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8C62CB-581A-B790-CF35-86C93EDB96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EE7C-DA2A-4B38-8566-444DA9AAC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428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F8AFCC-E686-2FEF-EFBE-45EED773A1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4A4E68-0651-546D-1764-07CB2203FD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C75C13-16B1-133B-0958-23FAC78749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C1D5A5B-F930-F038-16BE-4D8C94C134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0A977F2-0C22-32F1-F4C0-2827EB1597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A9CD24B-4804-AD77-FBD5-08E274842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AD585-02C3-4E60-B62E-96C39366E3A9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BC9499A-6AD3-073F-9483-83D671EAE9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7B26A9D-F46F-8D6C-3E7F-E61950A5D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EE7C-DA2A-4B38-8566-444DA9AAC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3565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0FD86-E509-D51B-F0CF-2B25A7DD4F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A43BCCC-AE4C-A8FC-90FB-7D68E31E71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AD585-02C3-4E60-B62E-96C39366E3A9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2217EF4-A382-4C60-13F8-C0818E1CB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3C1F7E7-698B-6C11-5577-92501D1AC9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EE7C-DA2A-4B38-8566-444DA9AAC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614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B76B404-455A-AB1E-B80D-80577938AE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AD585-02C3-4E60-B62E-96C39366E3A9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86ADA0A-E396-AE05-A0C5-5668416B4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E545AB-D509-6B03-95E7-D2BA8D3D9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EE7C-DA2A-4B38-8566-444DA9AAC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870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B4C086-6E3A-58D0-7671-B643A48D28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A5E74E-EB1F-B295-74B8-372DA67301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AAD2DD-0547-0B53-A1A5-8014787643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493AF5-DDCB-3658-8F82-E0A755C41A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AD585-02C3-4E60-B62E-96C39366E3A9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AA41BD-8E01-17BA-0B0A-C79027AC40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76D9E2-3719-BC83-BCDC-AFD01216C9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EE7C-DA2A-4B38-8566-444DA9AAC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793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C073C1-C2D2-F998-A2C8-0BDA7BF88B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8ADE714-3E05-0EF5-658A-CFCE592521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E8D79B-3AAF-3B80-5E6E-B123F4575C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83F21B-B9EC-83B2-4E83-28219A653B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AD585-02C3-4E60-B62E-96C39366E3A9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1892E1-4516-24E7-8E1B-4CC8B23C3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69F54A-EC30-42CB-5303-F112F044D3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ABEE7C-DA2A-4B38-8566-444DA9AAC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984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87D90B3-6F54-34B9-2412-3610D90446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6C4D8C-077A-39AD-8323-7C1BAFB85E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186813-E163-DA23-A364-5E663D06AF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8AD585-02C3-4E60-B62E-96C39366E3A9}" type="datetimeFigureOut">
              <a:rPr lang="en-US" smtClean="0"/>
              <a:t>4/2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3E7302-9D51-BDED-1210-BE5B9093F8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1315EA-852B-19C1-4187-D527616D30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ABEE7C-DA2A-4B38-8566-444DA9AAC0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12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  <a:latin typeface="Calibri Light" panose="020F0302020204030204" pitchFamily="34" charset="0"/>
                <a:ea typeface="Calibri Light" panose="020F0302020204030204" pitchFamily="34" charset="0"/>
                <a:cs typeface="Calibri Light" panose="020F0302020204030204" pitchFamily="34" charset="0"/>
              </a:rPr>
              <a:t>Patterns of damage observed on DMSA kidney scans and future risk of UTIs or reduced kidney function</a:t>
            </a:r>
            <a:endParaRPr lang="en-US" sz="2800" dirty="0">
              <a:solidFill>
                <a:schemeClr val="bg1"/>
              </a:solidFill>
              <a:latin typeface="Calibri Light" panose="020F0302020204030204" pitchFamily="34" charset="0"/>
              <a:ea typeface="Calibri Light" panose="020F0302020204030204" pitchFamily="34" charset="0"/>
              <a:cs typeface="Calibri Light" panose="020F030202020403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anaan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68390"/>
            <a:ext cx="730712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Focal defects</a:t>
            </a:r>
            <a:r>
              <a:rPr lang="en-US" sz="1800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, likely representing post pyelonephritis scars, are a strong predictor of recurrent UTIs. Patients with d</a:t>
            </a:r>
            <a:r>
              <a:rPr lang="en-US" dirty="0">
                <a:solidFill>
                  <a:schemeClr val="bg1"/>
                </a:solidFill>
              </a:rPr>
              <a:t>iffuse inhomogeneity with focal defects</a:t>
            </a:r>
            <a:r>
              <a:rPr lang="en-US" sz="1800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 have the highest risk of reduced eGFR during follow-up.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EEA3662-E107-7771-0E81-030C77DAB7C0}"/>
              </a:ext>
            </a:extLst>
          </p:cNvPr>
          <p:cNvSpPr txBox="1"/>
          <p:nvPr/>
        </p:nvSpPr>
        <p:spPr>
          <a:xfrm>
            <a:off x="243515" y="2096000"/>
            <a:ext cx="34309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etrospective single center study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E4B73127-7BB0-CCE2-3DAD-A80BE17F70D2}"/>
              </a:ext>
            </a:extLst>
          </p:cNvPr>
          <p:cNvCxnSpPr>
            <a:cxnSpLocks/>
          </p:cNvCxnSpPr>
          <p:nvPr/>
        </p:nvCxnSpPr>
        <p:spPr>
          <a:xfrm>
            <a:off x="3299381" y="3239492"/>
            <a:ext cx="2002480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E5FFB937-68C0-6F76-ED90-6FA7FB5AECA7}"/>
              </a:ext>
            </a:extLst>
          </p:cNvPr>
          <p:cNvSpPr txBox="1"/>
          <p:nvPr/>
        </p:nvSpPr>
        <p:spPr>
          <a:xfrm>
            <a:off x="3149408" y="2593161"/>
            <a:ext cx="23818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ollow up 99 patients</a:t>
            </a:r>
          </a:p>
          <a:p>
            <a:pPr algn="ctr"/>
            <a:r>
              <a:rPr lang="en-US" sz="1800" dirty="0">
                <a:effectLst/>
                <a:ea typeface="Times New Roman" panose="02020603050405020304" pitchFamily="18" charset="0"/>
              </a:rPr>
              <a:t>9.6±3.3 years </a:t>
            </a:r>
            <a:endParaRPr lang="en-US" dirty="0"/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9E604FF9-8F25-8362-1CB8-E8BD89E56E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33957331"/>
              </p:ext>
            </p:extLst>
          </p:nvPr>
        </p:nvGraphicFramePr>
        <p:xfrm>
          <a:off x="5478913" y="2047877"/>
          <a:ext cx="6469572" cy="183559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22782">
                  <a:extLst>
                    <a:ext uri="{9D8B030D-6E8A-4147-A177-3AD203B41FA5}">
                      <a16:colId xmlns:a16="http://schemas.microsoft.com/office/drawing/2014/main" val="2744772684"/>
                    </a:ext>
                  </a:extLst>
                </a:gridCol>
                <a:gridCol w="1159497">
                  <a:extLst>
                    <a:ext uri="{9D8B030D-6E8A-4147-A177-3AD203B41FA5}">
                      <a16:colId xmlns:a16="http://schemas.microsoft.com/office/drawing/2014/main" val="2432881238"/>
                    </a:ext>
                  </a:extLst>
                </a:gridCol>
                <a:gridCol w="961534">
                  <a:extLst>
                    <a:ext uri="{9D8B030D-6E8A-4147-A177-3AD203B41FA5}">
                      <a16:colId xmlns:a16="http://schemas.microsoft.com/office/drawing/2014/main" val="4197792016"/>
                    </a:ext>
                  </a:extLst>
                </a:gridCol>
                <a:gridCol w="867265">
                  <a:extLst>
                    <a:ext uri="{9D8B030D-6E8A-4147-A177-3AD203B41FA5}">
                      <a16:colId xmlns:a16="http://schemas.microsoft.com/office/drawing/2014/main" val="2865346836"/>
                    </a:ext>
                  </a:extLst>
                </a:gridCol>
                <a:gridCol w="822723">
                  <a:extLst>
                    <a:ext uri="{9D8B030D-6E8A-4147-A177-3AD203B41FA5}">
                      <a16:colId xmlns:a16="http://schemas.microsoft.com/office/drawing/2014/main" val="424833341"/>
                    </a:ext>
                  </a:extLst>
                </a:gridCol>
                <a:gridCol w="835771">
                  <a:extLst>
                    <a:ext uri="{9D8B030D-6E8A-4147-A177-3AD203B41FA5}">
                      <a16:colId xmlns:a16="http://schemas.microsoft.com/office/drawing/2014/main" val="1709336932"/>
                    </a:ext>
                  </a:extLst>
                </a:gridCol>
              </a:tblGrid>
              <a:tr h="358140">
                <a:tc>
                  <a:txBody>
                    <a:bodyPr/>
                    <a:lstStyle/>
                    <a:p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solidFill>
                            <a:srgbClr val="002060"/>
                          </a:solidFill>
                          <a:effectLst/>
                        </a:rPr>
                        <a:t>Normal DMSA (n=49)</a:t>
                      </a:r>
                      <a:endParaRPr lang="en-US" sz="1400" dirty="0">
                        <a:solidFill>
                          <a:srgbClr val="00206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solidFill>
                            <a:schemeClr val="accent6"/>
                          </a:solidFill>
                          <a:effectLst/>
                        </a:rPr>
                        <a:t>DI only (n=27)</a:t>
                      </a:r>
                      <a:endParaRPr lang="en-US" sz="1400" dirty="0">
                        <a:solidFill>
                          <a:schemeClr val="accent6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solidFill>
                            <a:srgbClr val="0070C0"/>
                          </a:solidFill>
                          <a:effectLst/>
                        </a:rPr>
                        <a:t>FD only (n=14)</a:t>
                      </a:r>
                      <a:endParaRPr lang="en-US" sz="1400" dirty="0">
                        <a:solidFill>
                          <a:srgbClr val="0070C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solidFill>
                            <a:srgbClr val="C00000"/>
                          </a:solidFill>
                          <a:effectLst/>
                        </a:rPr>
                        <a:t>DI+FD (n=9)</a:t>
                      </a:r>
                      <a:endParaRPr lang="en-US" sz="1400" dirty="0">
                        <a:solidFill>
                          <a:srgbClr val="C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</a:rPr>
                        <a:t>P value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6237078"/>
                  </a:ext>
                </a:extLst>
              </a:tr>
              <a:tr h="35814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recurrent UTIs, n(%)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9/49 (18.3%)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6/27 (22.2%)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10/14 (71.4%)</a:t>
                      </a:r>
                      <a:endParaRPr lang="en-US" sz="16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4/9 (44.4%)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P&lt;0.01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7574660"/>
                  </a:ext>
                </a:extLst>
              </a:tr>
              <a:tr h="35814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eGFR&lt;75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ml/min/1.73m</a:t>
                      </a:r>
                      <a:r>
                        <a:rPr lang="en-US" sz="1100" baseline="3000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n (%)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 (2%)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 (3.7%)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0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b="0" dirty="0">
                          <a:solidFill>
                            <a:schemeClr val="tx1"/>
                          </a:solidFill>
                          <a:effectLst/>
                        </a:rPr>
                        <a:t>2 (22%)</a:t>
                      </a:r>
                      <a:endParaRPr lang="en-US" sz="1600" b="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0.032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0673817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46F5CAFB-227F-1200-28F2-030F4093FE1E}"/>
              </a:ext>
            </a:extLst>
          </p:cNvPr>
          <p:cNvSpPr txBox="1"/>
          <p:nvPr/>
        </p:nvSpPr>
        <p:spPr>
          <a:xfrm>
            <a:off x="184354" y="3386587"/>
            <a:ext cx="13763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rgbClr val="002060"/>
                </a:solidFill>
              </a:rPr>
              <a:t>Normal scan 53 (50.5%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FC8D87E-13EB-3ACF-53EA-CAACB50897CA}"/>
              </a:ext>
            </a:extLst>
          </p:cNvPr>
          <p:cNvSpPr txBox="1"/>
          <p:nvPr/>
        </p:nvSpPr>
        <p:spPr>
          <a:xfrm>
            <a:off x="0" y="4870465"/>
            <a:ext cx="1838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chemeClr val="accent1"/>
                </a:solidFill>
              </a:rPr>
              <a:t>Focal defects (FD)</a:t>
            </a:r>
          </a:p>
          <a:p>
            <a:pPr algn="ctr"/>
            <a:r>
              <a:rPr lang="en-US" dirty="0">
                <a:solidFill>
                  <a:schemeClr val="accent1"/>
                </a:solidFill>
              </a:rPr>
              <a:t>14 (13.3%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74A8F20-7F4F-EB1F-2F42-994463DCAA04}"/>
              </a:ext>
            </a:extLst>
          </p:cNvPr>
          <p:cNvSpPr txBox="1"/>
          <p:nvPr/>
        </p:nvSpPr>
        <p:spPr>
          <a:xfrm>
            <a:off x="1651163" y="3388567"/>
            <a:ext cx="27262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chemeClr val="accent6"/>
                </a:solidFill>
              </a:rPr>
              <a:t>Diffuse inhomogeneity (DI)</a:t>
            </a:r>
          </a:p>
          <a:p>
            <a:pPr algn="ctr"/>
            <a:r>
              <a:rPr lang="en-US" dirty="0">
                <a:solidFill>
                  <a:schemeClr val="accent6"/>
                </a:solidFill>
              </a:rPr>
              <a:t>29 (27.6%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A206569-6F3E-E24A-D8A0-894668060EB3}"/>
              </a:ext>
            </a:extLst>
          </p:cNvPr>
          <p:cNvSpPr txBox="1"/>
          <p:nvPr/>
        </p:nvSpPr>
        <p:spPr>
          <a:xfrm>
            <a:off x="1613575" y="4812129"/>
            <a:ext cx="272628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rgbClr val="C00000"/>
                </a:solidFill>
              </a:rPr>
              <a:t>Diffuse inhomogeneity with focal defects (DI+FD)</a:t>
            </a:r>
          </a:p>
          <a:p>
            <a:pPr algn="ctr"/>
            <a:r>
              <a:rPr lang="en-US" dirty="0">
                <a:solidFill>
                  <a:srgbClr val="C00000"/>
                </a:solidFill>
              </a:rPr>
              <a:t>9 (8.6%)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DFA038DB-71D3-1B47-919F-AB34CE3748B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6482" y="4091254"/>
            <a:ext cx="352055" cy="720875"/>
          </a:xfrm>
          <a:prstGeom prst="rect">
            <a:avLst/>
          </a:prstGeom>
        </p:spPr>
      </p:pic>
      <p:sp>
        <p:nvSpPr>
          <p:cNvPr id="23" name="Freeform: Shape 46">
            <a:extLst>
              <a:ext uri="{FF2B5EF4-FFF2-40B4-BE49-F238E27FC236}">
                <a16:creationId xmlns:a16="http://schemas.microsoft.com/office/drawing/2014/main" id="{514C900B-45F4-62D4-BBC6-4EB5DD871D3B}"/>
              </a:ext>
            </a:extLst>
          </p:cNvPr>
          <p:cNvSpPr/>
          <p:nvPr/>
        </p:nvSpPr>
        <p:spPr>
          <a:xfrm>
            <a:off x="741731" y="2656966"/>
            <a:ext cx="352055" cy="75956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9" name="Freeform: Shape 46">
            <a:extLst>
              <a:ext uri="{FF2B5EF4-FFF2-40B4-BE49-F238E27FC236}">
                <a16:creationId xmlns:a16="http://schemas.microsoft.com/office/drawing/2014/main" id="{7B765144-F6ED-D76D-02D4-C12C6F7E7129}"/>
              </a:ext>
            </a:extLst>
          </p:cNvPr>
          <p:cNvSpPr/>
          <p:nvPr/>
        </p:nvSpPr>
        <p:spPr>
          <a:xfrm>
            <a:off x="2633890" y="2667205"/>
            <a:ext cx="352056" cy="759561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1" name="Freeform: Shape 46">
            <a:extLst>
              <a:ext uri="{FF2B5EF4-FFF2-40B4-BE49-F238E27FC236}">
                <a16:creationId xmlns:a16="http://schemas.microsoft.com/office/drawing/2014/main" id="{952A5AAB-B7FA-260F-3745-F632DA9033DC}"/>
              </a:ext>
            </a:extLst>
          </p:cNvPr>
          <p:cNvSpPr/>
          <p:nvPr/>
        </p:nvSpPr>
        <p:spPr>
          <a:xfrm>
            <a:off x="2633890" y="4091254"/>
            <a:ext cx="352056" cy="72673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5E1EC38-4E61-ED07-36A2-7ECAA6A6854E}"/>
              </a:ext>
            </a:extLst>
          </p:cNvPr>
          <p:cNvSpPr txBox="1"/>
          <p:nvPr/>
        </p:nvSpPr>
        <p:spPr>
          <a:xfrm>
            <a:off x="5478913" y="4091254"/>
            <a:ext cx="646957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Presence of FD predicted higher risk of recurrent UTIs [OR (95%CI): 3.89 (1.2, 12.6), p=0.024]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At last follow-up eGFR was lower in patients with DI+FD compared to all other groups</a:t>
            </a:r>
            <a:r>
              <a:rPr lang="en-US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</a:t>
            </a:r>
            <a:r>
              <a:rPr lang="en-US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p</a:t>
            </a:r>
            <a:r>
              <a:rPr lang="en-US">
                <a:latin typeface="Times New Roman" panose="02020603050405020304" pitchFamily="18" charset="0"/>
                <a:ea typeface="Times New Roman" panose="02020603050405020304" pitchFamily="18" charset="0"/>
              </a:rPr>
              <a:t>=0.006</a:t>
            </a:r>
            <a:endParaRPr lang="en-US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23596" y="1029296"/>
            <a:ext cx="119684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</a:t>
            </a:r>
            <a:r>
              <a:rPr lang="en-US" dirty="0">
                <a:effectLst/>
                <a:ea typeface="Times New Roman" panose="02020603050405020304" pitchFamily="18" charset="0"/>
              </a:rPr>
              <a:t> </a:t>
            </a:r>
            <a:r>
              <a:rPr lang="en-US" dirty="0">
                <a:solidFill>
                  <a:schemeClr val="bg1">
                    <a:lumMod val="95000"/>
                  </a:schemeClr>
                </a:solidFill>
                <a:ea typeface="Times New Roman" panose="02020603050405020304" pitchFamily="18" charset="0"/>
              </a:rPr>
              <a:t>D</a:t>
            </a:r>
            <a:r>
              <a:rPr lang="en-US" dirty="0">
                <a:solidFill>
                  <a:schemeClr val="bg1">
                    <a:lumMod val="95000"/>
                  </a:schemeClr>
                </a:solidFill>
                <a:effectLst/>
                <a:ea typeface="Times New Roman" panose="02020603050405020304" pitchFamily="18" charset="0"/>
              </a:rPr>
              <a:t>etermine the prognostic significance of different DMSA uptake patterns: peripheral focal defects, diffuse inhomogeneity in tracer distribution or a combination of both patterns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</TotalTime>
  <Words>263</Words>
  <Application>Microsoft Office PowerPoint</Application>
  <PresentationFormat>Widescreen</PresentationFormat>
  <Paragraphs>3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Orly Haskin</dc:creator>
  <cp:lastModifiedBy>Laycock, Joseph</cp:lastModifiedBy>
  <cp:revision>8</cp:revision>
  <dcterms:created xsi:type="dcterms:W3CDTF">2024-11-02T11:50:11Z</dcterms:created>
  <dcterms:modified xsi:type="dcterms:W3CDTF">2025-04-22T15:32:23Z</dcterms:modified>
</cp:coreProperties>
</file>